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D51B34"/>
    <a:srgbClr val="780A58"/>
    <a:srgbClr val="18FF9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200" d="100"/>
          <a:sy n="200" d="100"/>
        </p:scale>
        <p:origin x="1904" y="-96"/>
      </p:cViewPr>
      <p:guideLst>
        <p:guide orient="horz" pos="1044"/>
        <p:guide pos="40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691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85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593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261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872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442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94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0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691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799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781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051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6" name="Straight Arrow Connector 25"/>
          <p:cNvCxnSpPr/>
          <p:nvPr/>
        </p:nvCxnSpPr>
        <p:spPr>
          <a:xfrm>
            <a:off x="427567" y="2579702"/>
            <a:ext cx="4504266" cy="0"/>
          </a:xfrm>
          <a:prstGeom prst="straightConnector1">
            <a:avLst/>
          </a:prstGeom>
          <a:ln w="6350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864097" y="2419602"/>
            <a:ext cx="5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APLP2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133579" y="905595"/>
            <a:ext cx="11175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% of maximum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722" y="454735"/>
            <a:ext cx="2156985" cy="94462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7694" y="454735"/>
            <a:ext cx="2139522" cy="94462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35224" y="454735"/>
            <a:ext cx="2349595" cy="944628"/>
          </a:xfrm>
          <a:prstGeom prst="rect">
            <a:avLst/>
          </a:prstGeom>
        </p:spPr>
      </p:pic>
      <p:grpSp>
        <p:nvGrpSpPr>
          <p:cNvPr id="54" name="Group 53"/>
          <p:cNvGrpSpPr/>
          <p:nvPr/>
        </p:nvGrpSpPr>
        <p:grpSpPr>
          <a:xfrm>
            <a:off x="3926534" y="442795"/>
            <a:ext cx="994550" cy="831983"/>
            <a:chOff x="5567951" y="1985088"/>
            <a:chExt cx="994550" cy="831983"/>
          </a:xfrm>
        </p:grpSpPr>
        <p:cxnSp>
          <p:nvCxnSpPr>
            <p:cNvPr id="37" name="Straight Connector 36"/>
            <p:cNvCxnSpPr/>
            <p:nvPr/>
          </p:nvCxnSpPr>
          <p:spPr>
            <a:xfrm>
              <a:off x="5567951" y="2133600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5567951" y="2269067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5576412" y="2421467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5584873" y="2573867"/>
              <a:ext cx="237066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5593334" y="2726267"/>
              <a:ext cx="237066" cy="0"/>
            </a:xfrm>
            <a:prstGeom prst="line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5745730" y="1985088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745724" y="2137488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745724" y="2289894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762658" y="2442300"/>
              <a:ext cx="7998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762658" y="2586239"/>
              <a:ext cx="4540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79" name="Group 78"/>
          <p:cNvGrpSpPr/>
          <p:nvPr/>
        </p:nvGrpSpPr>
        <p:grpSpPr>
          <a:xfrm>
            <a:off x="1753144" y="441687"/>
            <a:ext cx="994550" cy="831983"/>
            <a:chOff x="5567951" y="1985088"/>
            <a:chExt cx="994550" cy="831983"/>
          </a:xfrm>
        </p:grpSpPr>
        <p:cxnSp>
          <p:nvCxnSpPr>
            <p:cNvPr id="80" name="Straight Connector 79"/>
            <p:cNvCxnSpPr/>
            <p:nvPr/>
          </p:nvCxnSpPr>
          <p:spPr>
            <a:xfrm>
              <a:off x="5567951" y="2133600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5567951" y="2269067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>
              <a:off x="5576412" y="2421467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>
              <a:off x="5584873" y="2573867"/>
              <a:ext cx="237066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>
              <a:off x="5593334" y="2726267"/>
              <a:ext cx="237066" cy="0"/>
            </a:xfrm>
            <a:prstGeom prst="line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/>
            <p:cNvSpPr txBox="1"/>
            <p:nvPr/>
          </p:nvSpPr>
          <p:spPr>
            <a:xfrm>
              <a:off x="5745730" y="1985088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5745724" y="2137488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745724" y="2289894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5762658" y="2442300"/>
              <a:ext cx="7998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5762658" y="2586239"/>
              <a:ext cx="4540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90" name="TextBox 89"/>
          <p:cNvSpPr txBox="1"/>
          <p:nvPr/>
        </p:nvSpPr>
        <p:spPr>
          <a:xfrm>
            <a:off x="1332920" y="196574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Times New Roman"/>
                <a:cs typeface="Times New Roman"/>
              </a:rPr>
              <a:t>Jurkat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3564678" y="207095"/>
            <a:ext cx="5409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JINB8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654660" y="194835"/>
            <a:ext cx="1181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JINB8 + CD47-V5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cxnSp>
        <p:nvCxnSpPr>
          <p:cNvPr id="94" name="Straight Arrow Connector 93"/>
          <p:cNvCxnSpPr/>
          <p:nvPr/>
        </p:nvCxnSpPr>
        <p:spPr>
          <a:xfrm flipH="1" flipV="1">
            <a:off x="427567" y="1524000"/>
            <a:ext cx="1758" cy="1055702"/>
          </a:xfrm>
          <a:prstGeom prst="straightConnector1">
            <a:avLst/>
          </a:prstGeom>
          <a:ln w="6350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96" name="Picture 9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6220" y="1490550"/>
            <a:ext cx="2165349" cy="950975"/>
          </a:xfrm>
          <a:prstGeom prst="rect">
            <a:avLst/>
          </a:prstGeom>
        </p:spPr>
      </p:pic>
      <p:pic>
        <p:nvPicPr>
          <p:cNvPr id="97" name="Picture 9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48719" y="1494088"/>
            <a:ext cx="2134431" cy="950975"/>
          </a:xfrm>
          <a:prstGeom prst="rect">
            <a:avLst/>
          </a:prstGeom>
        </p:spPr>
      </p:pic>
      <p:pic>
        <p:nvPicPr>
          <p:cNvPr id="98" name="Picture 9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31668" y="1502270"/>
            <a:ext cx="2353152" cy="950975"/>
          </a:xfrm>
          <a:prstGeom prst="rect">
            <a:avLst/>
          </a:prstGeom>
        </p:spPr>
      </p:pic>
      <p:grpSp>
        <p:nvGrpSpPr>
          <p:cNvPr id="99" name="Group 98"/>
          <p:cNvGrpSpPr/>
          <p:nvPr/>
        </p:nvGrpSpPr>
        <p:grpSpPr>
          <a:xfrm>
            <a:off x="6353770" y="482365"/>
            <a:ext cx="994550" cy="831983"/>
            <a:chOff x="5567951" y="1985088"/>
            <a:chExt cx="994550" cy="831983"/>
          </a:xfrm>
        </p:grpSpPr>
        <p:cxnSp>
          <p:nvCxnSpPr>
            <p:cNvPr id="100" name="Straight Connector 99"/>
            <p:cNvCxnSpPr/>
            <p:nvPr/>
          </p:nvCxnSpPr>
          <p:spPr>
            <a:xfrm>
              <a:off x="5567951" y="2133600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5567951" y="2269067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>
              <a:off x="5576412" y="2421467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/>
            <p:nvPr/>
          </p:nvCxnSpPr>
          <p:spPr>
            <a:xfrm>
              <a:off x="5584873" y="2573867"/>
              <a:ext cx="237066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03"/>
            <p:cNvCxnSpPr/>
            <p:nvPr/>
          </p:nvCxnSpPr>
          <p:spPr>
            <a:xfrm>
              <a:off x="5593334" y="2726267"/>
              <a:ext cx="237066" cy="0"/>
            </a:xfrm>
            <a:prstGeom prst="line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/>
            <p:cNvSpPr txBox="1"/>
            <p:nvPr/>
          </p:nvSpPr>
          <p:spPr>
            <a:xfrm>
              <a:off x="5745730" y="1985088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5745724" y="2137488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5745724" y="2289894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5762658" y="2442300"/>
              <a:ext cx="7998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5762658" y="2586239"/>
              <a:ext cx="4540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25" name="Group 124"/>
          <p:cNvGrpSpPr/>
          <p:nvPr/>
        </p:nvGrpSpPr>
        <p:grpSpPr>
          <a:xfrm>
            <a:off x="1572079" y="1490550"/>
            <a:ext cx="1176128" cy="831983"/>
            <a:chOff x="4800477" y="2925645"/>
            <a:chExt cx="1176128" cy="831983"/>
          </a:xfrm>
        </p:grpSpPr>
        <p:cxnSp>
          <p:nvCxnSpPr>
            <p:cNvPr id="115" name="Straight Connector 114"/>
            <p:cNvCxnSpPr/>
            <p:nvPr/>
          </p:nvCxnSpPr>
          <p:spPr>
            <a:xfrm>
              <a:off x="4800477" y="3074157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Straight Connector 115"/>
            <p:cNvCxnSpPr/>
            <p:nvPr/>
          </p:nvCxnSpPr>
          <p:spPr>
            <a:xfrm>
              <a:off x="4800477" y="3209624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>
              <a:off x="4808938" y="3362024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4817399" y="3514424"/>
              <a:ext cx="237066" cy="0"/>
            </a:xfrm>
            <a:prstGeom prst="line">
              <a:avLst/>
            </a:prstGeom>
            <a:ln>
              <a:solidFill>
                <a:srgbClr val="780A58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4825860" y="3666824"/>
              <a:ext cx="237066" cy="0"/>
            </a:xfrm>
            <a:prstGeom prst="line">
              <a:avLst/>
            </a:prstGeom>
            <a:ln>
              <a:solidFill>
                <a:srgbClr val="D51B34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/>
            <p:cNvSpPr txBox="1"/>
            <p:nvPr/>
          </p:nvSpPr>
          <p:spPr>
            <a:xfrm>
              <a:off x="4978256" y="2925645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4978250" y="3078045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4978250" y="3230451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4995184" y="3382857"/>
              <a:ext cx="981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4995184" y="3526796"/>
              <a:ext cx="6335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26" name="Group 125"/>
          <p:cNvGrpSpPr/>
          <p:nvPr/>
        </p:nvGrpSpPr>
        <p:grpSpPr>
          <a:xfrm>
            <a:off x="6174710" y="1524000"/>
            <a:ext cx="1176128" cy="831983"/>
            <a:chOff x="4800477" y="2925645"/>
            <a:chExt cx="1176128" cy="831983"/>
          </a:xfrm>
        </p:grpSpPr>
        <p:cxnSp>
          <p:nvCxnSpPr>
            <p:cNvPr id="127" name="Straight Connector 126"/>
            <p:cNvCxnSpPr/>
            <p:nvPr/>
          </p:nvCxnSpPr>
          <p:spPr>
            <a:xfrm>
              <a:off x="4800477" y="3074157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8" name="Straight Connector 127"/>
            <p:cNvCxnSpPr/>
            <p:nvPr/>
          </p:nvCxnSpPr>
          <p:spPr>
            <a:xfrm>
              <a:off x="4800477" y="3209624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Straight Connector 128"/>
            <p:cNvCxnSpPr/>
            <p:nvPr/>
          </p:nvCxnSpPr>
          <p:spPr>
            <a:xfrm>
              <a:off x="4808938" y="3362024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/>
            <p:cNvCxnSpPr/>
            <p:nvPr/>
          </p:nvCxnSpPr>
          <p:spPr>
            <a:xfrm>
              <a:off x="4817399" y="3514424"/>
              <a:ext cx="237066" cy="0"/>
            </a:xfrm>
            <a:prstGeom prst="line">
              <a:avLst/>
            </a:prstGeom>
            <a:ln>
              <a:solidFill>
                <a:srgbClr val="780A58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/>
            <p:cNvCxnSpPr/>
            <p:nvPr/>
          </p:nvCxnSpPr>
          <p:spPr>
            <a:xfrm>
              <a:off x="4825860" y="3666824"/>
              <a:ext cx="237066" cy="0"/>
            </a:xfrm>
            <a:prstGeom prst="line">
              <a:avLst/>
            </a:prstGeom>
            <a:ln>
              <a:solidFill>
                <a:srgbClr val="D51B34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131"/>
            <p:cNvSpPr txBox="1"/>
            <p:nvPr/>
          </p:nvSpPr>
          <p:spPr>
            <a:xfrm>
              <a:off x="4978256" y="2925645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978250" y="3078045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4978250" y="3230451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4995184" y="3382857"/>
              <a:ext cx="981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4995184" y="3526796"/>
              <a:ext cx="6335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37" name="Group 136"/>
          <p:cNvGrpSpPr/>
          <p:nvPr/>
        </p:nvGrpSpPr>
        <p:grpSpPr>
          <a:xfrm>
            <a:off x="3782193" y="1495920"/>
            <a:ext cx="1176128" cy="831983"/>
            <a:chOff x="4800477" y="2925645"/>
            <a:chExt cx="1176128" cy="831983"/>
          </a:xfrm>
        </p:grpSpPr>
        <p:cxnSp>
          <p:nvCxnSpPr>
            <p:cNvPr id="138" name="Straight Connector 137"/>
            <p:cNvCxnSpPr/>
            <p:nvPr/>
          </p:nvCxnSpPr>
          <p:spPr>
            <a:xfrm>
              <a:off x="4800477" y="3074157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/>
            <p:nvPr/>
          </p:nvCxnSpPr>
          <p:spPr>
            <a:xfrm>
              <a:off x="4800477" y="3209624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4808938" y="3362024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/>
            <p:nvPr/>
          </p:nvCxnSpPr>
          <p:spPr>
            <a:xfrm>
              <a:off x="4817399" y="3514424"/>
              <a:ext cx="237066" cy="0"/>
            </a:xfrm>
            <a:prstGeom prst="line">
              <a:avLst/>
            </a:prstGeom>
            <a:ln>
              <a:solidFill>
                <a:srgbClr val="780A58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/>
            <p:cNvCxnSpPr/>
            <p:nvPr/>
          </p:nvCxnSpPr>
          <p:spPr>
            <a:xfrm>
              <a:off x="4825860" y="3666824"/>
              <a:ext cx="237066" cy="0"/>
            </a:xfrm>
            <a:prstGeom prst="line">
              <a:avLst/>
            </a:prstGeom>
            <a:ln>
              <a:solidFill>
                <a:srgbClr val="D51B34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142"/>
            <p:cNvSpPr txBox="1"/>
            <p:nvPr/>
          </p:nvSpPr>
          <p:spPr>
            <a:xfrm>
              <a:off x="4978256" y="2925645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4978250" y="3078045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4978250" y="3230451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4995184" y="3382857"/>
              <a:ext cx="981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4995184" y="3526796"/>
              <a:ext cx="6335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849595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53</Words>
  <Application>Microsoft Macintosh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ational Institutes of Healt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. I. A. I. D. N. I. H.</dc:creator>
  <cp:lastModifiedBy>N. I. A. I. D. N. I. H.</cp:lastModifiedBy>
  <cp:revision>15</cp:revision>
  <cp:lastPrinted>2012-12-31T16:32:33Z</cp:lastPrinted>
  <dcterms:created xsi:type="dcterms:W3CDTF">2012-08-29T18:03:54Z</dcterms:created>
  <dcterms:modified xsi:type="dcterms:W3CDTF">2012-12-31T17:43:22Z</dcterms:modified>
</cp:coreProperties>
</file>